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57" d="100"/>
          <a:sy n="57" d="100"/>
        </p:scale>
        <p:origin x="396" y="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A48B28B-8850-49D3-A0AF-F3F497DE0F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54B48DE-72CF-42D7-BD4A-C8AC3E927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A911DCC-3904-4898-A0E3-C9E5C549B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52A7D06-DF54-4252-9168-23A1FE12A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A56EA5A-8CCF-4C6C-A396-BA0E010B2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797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192ACF2-09FE-4C4A-B089-5EF4B43A0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D922EAF9-EB6B-45FD-B0CA-2409CAEE34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23C892E-2B60-43E3-8843-0F0A30398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623B654-64D2-4FFA-8B36-5EF4A139F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DFE16CD-DA96-483F-810C-6C986FB6C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446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78D5F955-467D-4F24-B2B8-78D7B447F5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F267F0B-0952-470C-A1C7-A7CD481AB6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522B84F-F10B-4ADA-B4C8-11EE145279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D37315E-8D0D-49FB-9085-1948105B3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24616C4-3319-4907-9B0C-C39B3822A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022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BC1B469-F5BF-4A82-BBAA-DDA7729D28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DBD4A56-71E2-48C5-9DE1-2BDCC88ED1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2B057B1-7192-4521-B1C0-28FBE17FD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9A33A35-3ED9-4FB2-8F35-1220662FB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592EA47-0E3F-42BC-A709-259AFB793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513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0F24F15-ABA2-4AEE-88C9-1ACDD83072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B2E4E814-12F8-4FEF-925E-2DE20415BE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87E2D7F-D9AA-4D17-A93B-BCB29BDB3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7092F2B9-B15E-4739-973B-49F20EF27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50FB595-D9B9-4246-9EE1-11BDC1B1A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466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572E538-573C-492F-9E6C-4621213B73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AEAD07F-6C8E-467D-99FD-16474D5045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0EC708AC-6D8C-4A3A-AD30-5370201E2B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92911C5B-C9DE-41AF-A606-3D914A26E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197F4554-4C82-4B13-9597-647F05D7A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141F0FD5-C6B6-42D8-BDD6-7CA1DB827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029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2E8E87F-5A40-4FBE-B77F-EF34636C9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EE7EC5C6-60C1-48B1-88E0-FD0E300540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BA4AE7FD-D4E3-407A-A6C8-E7F736E1D4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9CEDBDF5-3118-41DE-9651-725CFB6EEA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42ED0A34-F083-4865-8A06-22ABEF68B4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C78D8A29-BB84-4BA7-B476-7952925E1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1FF8E03F-76D1-4445-8413-13B602D50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B9951690-46CF-4434-AA57-E082E54F8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132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2A42BD4-6943-4422-8773-373E969B59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01FF59DD-A26C-454D-9D8C-9240BB766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7862C200-004F-4932-8523-0C6640B6A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22A93D27-D60F-400A-9D4E-8AA27C59F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81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8DFCC562-D128-465F-93D9-7B80AC626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7C0EC3E7-0F55-4790-A5DB-2D77FD3CF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93EB288D-3A7E-4F2E-A490-C6DA3493C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491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31DF811-05B7-4E58-B9F5-8AF388071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9CB7B9D-A928-436E-AA0C-F09B787465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3698A189-89DC-4220-BEE8-21B3AE18EB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2C291080-8870-4B41-9369-CED46C3CB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2F994FF-2E16-4E0E-ABB4-C1241C1F8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E623A21F-7A11-477E-86C2-5B9624B8C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176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9D5DD2F-4A5D-4C29-9758-0582EE5E2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AAAC8379-633B-48F6-A164-EA538A0665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42A501B8-F9EF-411D-BD1C-3A853AF8C6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3A43A7F-4169-4F99-8CB1-E990697966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251FCFBA-D2BD-4073-A4FA-11B116A2D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DED1F70-3A36-4397-A2A4-3355145A4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4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C9553FA5-9A24-4FC3-9B09-0E249E2AA9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3C9EDA-0962-48D6-8320-96514AC627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4F2F545-6518-4553-B58F-9E186F2510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11C2E-C215-4351-94A3-8C4766F6255C}" type="datetimeFigureOut">
              <a:rPr lang="en-US" smtClean="0"/>
              <a:t>5/1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93DB303-471B-44C6-A3FD-DE809CF8B0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14B5C2C-061A-4786-ADCF-21BE2C4E46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E605C-6090-46B6-B23C-265065CA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904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0F76105A-066E-4F27-815F-29875CC2D2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7812" y="232466"/>
            <a:ext cx="4120737" cy="221999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4021EF91-B850-4652-8C7C-C2FEE69C912C}"/>
              </a:ext>
            </a:extLst>
          </p:cNvPr>
          <p:cNvSpPr txBox="1"/>
          <p:nvPr/>
        </p:nvSpPr>
        <p:spPr>
          <a:xfrm>
            <a:off x="2987472" y="321530"/>
            <a:ext cx="18049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SH - PO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687003EA-1778-44AD-8F85-5E0577AA94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0740" y="410321"/>
            <a:ext cx="3788369" cy="204213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088DF0A9-26C5-49BC-8469-B639E5E78CF4}"/>
              </a:ext>
            </a:extLst>
          </p:cNvPr>
          <p:cNvSpPr txBox="1"/>
          <p:nvPr/>
        </p:nvSpPr>
        <p:spPr>
          <a:xfrm>
            <a:off x="6907779" y="321530"/>
            <a:ext cx="18727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SH - NEG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="" xmlns:a16="http://schemas.microsoft.com/office/drawing/2014/main" id="{8D3C6057-1092-4CA2-8B1A-A4F3AF14C2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66243" y="3180430"/>
            <a:ext cx="4269179" cy="226632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D12202E2-E380-4B18-A645-49AA8B4FB7A2}"/>
              </a:ext>
            </a:extLst>
          </p:cNvPr>
          <p:cNvSpPr txBox="1"/>
          <p:nvPr/>
        </p:nvSpPr>
        <p:spPr>
          <a:xfrm>
            <a:off x="3092054" y="2718765"/>
            <a:ext cx="19693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ILIC - PO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="" xmlns:a16="http://schemas.microsoft.com/office/drawing/2014/main" id="{498F2875-F14B-4867-8A86-25DECA86CB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18549" y="3134095"/>
            <a:ext cx="4188177" cy="226632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FEA4BA04-6B3B-401F-9BF7-3FC28996078D}"/>
              </a:ext>
            </a:extLst>
          </p:cNvPr>
          <p:cNvSpPr txBox="1"/>
          <p:nvPr/>
        </p:nvSpPr>
        <p:spPr>
          <a:xfrm>
            <a:off x="6850812" y="2721649"/>
            <a:ext cx="19139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ILIC - NE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1B2D4A4C-3766-431C-8FF8-A440FB9EE9F5}"/>
              </a:ext>
            </a:extLst>
          </p:cNvPr>
          <p:cNvSpPr txBox="1"/>
          <p:nvPr/>
        </p:nvSpPr>
        <p:spPr>
          <a:xfrm>
            <a:off x="5019040" y="5515342"/>
            <a:ext cx="26719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etention tim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A045691F-6160-4C55-ADBC-04E6DC55222C}"/>
              </a:ext>
            </a:extLst>
          </p:cNvPr>
          <p:cNvSpPr txBox="1"/>
          <p:nvPr/>
        </p:nvSpPr>
        <p:spPr>
          <a:xfrm rot="16200000">
            <a:off x="662669" y="2095852"/>
            <a:ext cx="164593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404089" y="5977007"/>
            <a:ext cx="963772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Overlaying total ion chromatograms for 20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IVT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human plasma quality control samples that were analyzed after every ten samples within a batch of 200 samples. Except HILIC-NEG, no major drift in the total signal was observed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4996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upal-pc</dc:creator>
  <cp:lastModifiedBy>MDPI</cp:lastModifiedBy>
  <cp:revision>8</cp:revision>
  <dcterms:created xsi:type="dcterms:W3CDTF">2019-05-10T20:22:25Z</dcterms:created>
  <dcterms:modified xsi:type="dcterms:W3CDTF">2019-05-17T03:45:57Z</dcterms:modified>
</cp:coreProperties>
</file>